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1" d="100"/>
          <a:sy n="101" d="100"/>
        </p:scale>
        <p:origin x="8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158280-1503-18F6-7B64-E20ED06716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220C662-E1FF-ED77-62D2-6EA1F028B2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543345-36B4-4D95-180F-5EBE203FE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35496-7024-4103-BED5-4301BBF41D5A}" type="datetimeFigureOut">
              <a:rPr lang="en-IN" smtClean="0"/>
              <a:t>02-10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2DA3FB-EE37-BBEC-940D-256B6E59E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3F3079-0152-6FB1-BD3D-8C2AAEF65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E7D62-46C2-4EF3-9756-366E09C2A20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24759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04CDE0-14DF-2EA3-B79C-4E3ACFCB6E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2C8672-E3EA-B074-0AB3-F6785295F0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1A751D-98AA-FC0F-5F3D-5B71CE6749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35496-7024-4103-BED5-4301BBF41D5A}" type="datetimeFigureOut">
              <a:rPr lang="en-IN" smtClean="0"/>
              <a:t>02-10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F86BCC-A810-EA5D-D349-DDAC240F4C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057096-D0D6-B913-EF58-B6CE51821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E7D62-46C2-4EF3-9756-366E09C2A20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7790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EC6F7A5-0FAE-CBA7-1BC0-F7DEC3A655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33A354-F7D3-3E0B-BA8E-9A7B022B6B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424C17-486C-05F8-9D4A-0B9226993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35496-7024-4103-BED5-4301BBF41D5A}" type="datetimeFigureOut">
              <a:rPr lang="en-IN" smtClean="0"/>
              <a:t>02-10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C6BE0A-88AD-5D79-725F-9F740D5F9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667568-82ED-92E5-1BEE-D6BEE6C15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E7D62-46C2-4EF3-9756-366E09C2A20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02310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B2BD4E-821F-BD4F-E3E7-E4CBFDB511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01AA7D-3338-1850-C004-501D5F0E62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B2C2F8-48F6-1C61-85DA-B10530B0AF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35496-7024-4103-BED5-4301BBF41D5A}" type="datetimeFigureOut">
              <a:rPr lang="en-IN" smtClean="0"/>
              <a:t>02-10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8FEBCE-CA60-A27C-BF76-E921C4E7B3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53A51C-1ABA-8714-B58A-BE4631AEF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E7D62-46C2-4EF3-9756-366E09C2A20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11518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435BF9-ECB8-204F-E4B7-9AF4DF3D6F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61DEB4-2B3A-108C-7D6A-724C427074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5970F2-D414-4B4C-A153-FA16C0173E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35496-7024-4103-BED5-4301BBF41D5A}" type="datetimeFigureOut">
              <a:rPr lang="en-IN" smtClean="0"/>
              <a:t>02-10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7D8804-6937-5F4E-7C4B-657BA9BB79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F0CBC3-613B-5E38-C3BC-2E6E31CF77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E7D62-46C2-4EF3-9756-366E09C2A20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10027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EE80DB-00CA-C07B-C09C-2003A729DF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5786A5-C82C-D78F-9F10-D072D1CEC5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365E42-0CAA-8152-74AB-C2B709275F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70D64C-E4CA-7BE8-C1CB-268EFCBB6E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35496-7024-4103-BED5-4301BBF41D5A}" type="datetimeFigureOut">
              <a:rPr lang="en-IN" smtClean="0"/>
              <a:t>02-10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94054F-BFC8-1648-26C7-3A939150F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AAE8CD-7961-C198-16AC-D386F5DEA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E7D62-46C2-4EF3-9756-366E09C2A20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01125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8AEEC1-2BB5-D3F5-52A7-84DA37D3DE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C615B7-E474-EF29-AD32-9AACD90604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5D79E7-36BE-A7F4-65C3-EDB6C6F937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9D5486-E638-CEB3-F69E-FC8ABE1F0C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27B7C14-5191-85CD-159D-4035479F51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E3DA27E-48A8-7762-B94F-9658F2C8A5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35496-7024-4103-BED5-4301BBF41D5A}" type="datetimeFigureOut">
              <a:rPr lang="en-IN" smtClean="0"/>
              <a:t>02-10-2023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DA30E6-F0BC-214A-6D04-50B62C7DD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33370E6-5C32-A9F4-42FF-8F2CDA67D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E7D62-46C2-4EF3-9756-366E09C2A20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29932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EF0D98-7E67-7E8C-A7CB-320539862E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3DB8DAA-CF01-1C32-B163-2E45B96CB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35496-7024-4103-BED5-4301BBF41D5A}" type="datetimeFigureOut">
              <a:rPr lang="en-IN" smtClean="0"/>
              <a:t>02-10-2023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1C03965-50DE-45A5-ABE2-0085B7008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1A5FEDB-9202-9192-F70B-9F6C01877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E7D62-46C2-4EF3-9756-366E09C2A20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93223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BF9185-7E8B-F9C9-2D1B-9FC252C4AB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35496-7024-4103-BED5-4301BBF41D5A}" type="datetimeFigureOut">
              <a:rPr lang="en-IN" smtClean="0"/>
              <a:t>02-10-2023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29C8EA0-C8B5-9101-5C84-77AC50D684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673D26-BC91-389D-9F02-20D537C387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E7D62-46C2-4EF3-9756-366E09C2A20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58065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F167C1-7A9C-D4EE-CBC7-632431340F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BC8F0B-6FCA-BA00-F808-179B055AEF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AFCB8C-37A7-3F0F-E924-F634FD0C1A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01B0E3-ADA2-E492-B9CD-FEEF4C4C0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35496-7024-4103-BED5-4301BBF41D5A}" type="datetimeFigureOut">
              <a:rPr lang="en-IN" smtClean="0"/>
              <a:t>02-10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6C987D-4620-F1D4-1D1F-6FD3A50B12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D7D8F5-AF33-C399-B36A-E09F3661B0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E7D62-46C2-4EF3-9756-366E09C2A20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15465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B3D0F5-C628-DB9D-CFFC-ACBC999EDC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4CB0A60-C569-CD5F-F3D6-4CD512BC68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1A2844-D74D-939F-D2D3-6A0B7D2F9D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40C791-0FB7-A4F2-FDAC-49DEF29576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35496-7024-4103-BED5-4301BBF41D5A}" type="datetimeFigureOut">
              <a:rPr lang="en-IN" smtClean="0"/>
              <a:t>02-10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27BE2F-788B-3B84-BAF3-77BD6C98E0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A4E15F-0136-FB58-C542-CA225D2A3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E7D62-46C2-4EF3-9756-366E09C2A20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77856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C41BC3-60B5-A0CC-8BEB-590992C8DF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0D3E87-40C6-1D04-3237-2D3C9FDA44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F37BB0-A263-EDF4-0A7E-8099F16066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35496-7024-4103-BED5-4301BBF41D5A}" type="datetimeFigureOut">
              <a:rPr lang="en-IN" smtClean="0"/>
              <a:t>02-10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5D2D3F-D65E-55CD-57D3-C299EEE24F2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5B9D58-D3D6-A630-222E-877374DFE3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FE7D62-46C2-4EF3-9756-366E09C2A20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10017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7B0B6BDB-7A7C-93E8-1B21-0C6739E89442}"/>
              </a:ext>
            </a:extLst>
          </p:cNvPr>
          <p:cNvSpPr txBox="1"/>
          <p:nvPr/>
        </p:nvSpPr>
        <p:spPr>
          <a:xfrm>
            <a:off x="1036825" y="726559"/>
            <a:ext cx="998499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IN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</a:t>
            </a:r>
            <a:r>
              <a:rPr lang="en-IN" sz="1400" dirty="0">
                <a:latin typeface="Arial" panose="020B0604020202020204" pitchFamily="34" charset="0"/>
                <a:cs typeface="Arial" panose="020B0604020202020204" pitchFamily="34" charset="0"/>
              </a:rPr>
              <a:t>: Different types of molecular interactions between Htf and Vanillin.</a:t>
            </a:r>
          </a:p>
        </p:txBody>
      </p:sp>
      <p:graphicFrame>
        <p:nvGraphicFramePr>
          <p:cNvPr id="19" name="Table 18">
            <a:extLst>
              <a:ext uri="{FF2B5EF4-FFF2-40B4-BE49-F238E27FC236}">
                <a16:creationId xmlns:a16="http://schemas.microsoft.com/office/drawing/2014/main" id="{9FCF28E8-0B90-B666-887F-1DE060FFD6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8329492"/>
              </p:ext>
            </p:extLst>
          </p:nvPr>
        </p:nvGraphicFramePr>
        <p:xfrm>
          <a:off x="1103503" y="3091602"/>
          <a:ext cx="9984996" cy="929640"/>
        </p:xfrm>
        <a:graphic>
          <a:graphicData uri="http://schemas.openxmlformats.org/drawingml/2006/table">
            <a:tbl>
              <a:tblPr/>
              <a:tblGrid>
                <a:gridCol w="1664166">
                  <a:extLst>
                    <a:ext uri="{9D8B030D-6E8A-4147-A177-3AD203B41FA5}">
                      <a16:colId xmlns:a16="http://schemas.microsoft.com/office/drawing/2014/main" val="271341792"/>
                    </a:ext>
                  </a:extLst>
                </a:gridCol>
                <a:gridCol w="1664166">
                  <a:extLst>
                    <a:ext uri="{9D8B030D-6E8A-4147-A177-3AD203B41FA5}">
                      <a16:colId xmlns:a16="http://schemas.microsoft.com/office/drawing/2014/main" val="2676558602"/>
                    </a:ext>
                  </a:extLst>
                </a:gridCol>
                <a:gridCol w="1664166">
                  <a:extLst>
                    <a:ext uri="{9D8B030D-6E8A-4147-A177-3AD203B41FA5}">
                      <a16:colId xmlns:a16="http://schemas.microsoft.com/office/drawing/2014/main" val="2397131252"/>
                    </a:ext>
                  </a:extLst>
                </a:gridCol>
                <a:gridCol w="1664166">
                  <a:extLst>
                    <a:ext uri="{9D8B030D-6E8A-4147-A177-3AD203B41FA5}">
                      <a16:colId xmlns:a16="http://schemas.microsoft.com/office/drawing/2014/main" val="2612292138"/>
                    </a:ext>
                  </a:extLst>
                </a:gridCol>
                <a:gridCol w="1664166">
                  <a:extLst>
                    <a:ext uri="{9D8B030D-6E8A-4147-A177-3AD203B41FA5}">
                      <a16:colId xmlns:a16="http://schemas.microsoft.com/office/drawing/2014/main" val="4185613317"/>
                    </a:ext>
                  </a:extLst>
                </a:gridCol>
                <a:gridCol w="1664166">
                  <a:extLst>
                    <a:ext uri="{9D8B030D-6E8A-4147-A177-3AD203B41FA5}">
                      <a16:colId xmlns:a16="http://schemas.microsoft.com/office/drawing/2014/main" val="253313723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 dirty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x</a:t>
                      </a:r>
                    </a:p>
                  </a:txBody>
                  <a:tcPr marL="47625" marR="47625" marT="95250" marB="9525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 dirty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due</a:t>
                      </a:r>
                    </a:p>
                  </a:txBody>
                  <a:tcPr marL="47625" marR="47625" marT="95250" marB="9525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 dirty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</a:t>
                      </a:r>
                    </a:p>
                  </a:txBody>
                  <a:tcPr marL="47625" marR="47625" marT="95250" marB="9525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nce</a:t>
                      </a:r>
                    </a:p>
                  </a:txBody>
                  <a:tcPr marL="47625" marR="47625" marT="95250" marB="9525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 dirty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gand Atom</a:t>
                      </a:r>
                    </a:p>
                  </a:txBody>
                  <a:tcPr marL="47625" marR="47625" marT="95250" marB="9525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Atom</a:t>
                      </a:r>
                    </a:p>
                  </a:txBody>
                  <a:tcPr marL="47625" marR="47625" marT="95250" marB="9525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22133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7A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P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2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87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62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5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85223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1A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G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7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88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07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1741973"/>
                  </a:ext>
                </a:extLst>
              </a:tr>
            </a:tbl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B071A072-8E98-1F10-646B-83D334B884B1}"/>
              </a:ext>
            </a:extLst>
          </p:cNvPr>
          <p:cNvSpPr txBox="1"/>
          <p:nvPr/>
        </p:nvSpPr>
        <p:spPr>
          <a:xfrm>
            <a:off x="998728" y="2823960"/>
            <a:ext cx="351021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IN" sz="1400" b="0" i="0" dirty="0">
                <a:solidFill>
                  <a:srgbClr val="00567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ydrophobic Interactions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4A5EC76E-272C-9E1C-BA5D-40EA98D86E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8425897"/>
              </p:ext>
            </p:extLst>
          </p:nvPr>
        </p:nvGraphicFramePr>
        <p:xfrm>
          <a:off x="1103500" y="1513305"/>
          <a:ext cx="10089774" cy="1175270"/>
        </p:xfrm>
        <a:graphic>
          <a:graphicData uri="http://schemas.openxmlformats.org/drawingml/2006/table">
            <a:tbl>
              <a:tblPr/>
              <a:tblGrid>
                <a:gridCol w="502989">
                  <a:extLst>
                    <a:ext uri="{9D8B030D-6E8A-4147-A177-3AD203B41FA5}">
                      <a16:colId xmlns:a16="http://schemas.microsoft.com/office/drawing/2014/main" val="2459175611"/>
                    </a:ext>
                  </a:extLst>
                </a:gridCol>
                <a:gridCol w="689582">
                  <a:extLst>
                    <a:ext uri="{9D8B030D-6E8A-4147-A177-3AD203B41FA5}">
                      <a16:colId xmlns:a16="http://schemas.microsoft.com/office/drawing/2014/main" val="1573766975"/>
                    </a:ext>
                  </a:extLst>
                </a:gridCol>
                <a:gridCol w="462425">
                  <a:extLst>
                    <a:ext uri="{9D8B030D-6E8A-4147-A177-3AD203B41FA5}">
                      <a16:colId xmlns:a16="http://schemas.microsoft.com/office/drawing/2014/main" val="3980374519"/>
                    </a:ext>
                  </a:extLst>
                </a:gridCol>
                <a:gridCol w="1078679">
                  <a:extLst>
                    <a:ext uri="{9D8B030D-6E8A-4147-A177-3AD203B41FA5}">
                      <a16:colId xmlns:a16="http://schemas.microsoft.com/office/drawing/2014/main" val="136808481"/>
                    </a:ext>
                  </a:extLst>
                </a:gridCol>
                <a:gridCol w="1266825">
                  <a:extLst>
                    <a:ext uri="{9D8B030D-6E8A-4147-A177-3AD203B41FA5}">
                      <a16:colId xmlns:a16="http://schemas.microsoft.com/office/drawing/2014/main" val="4108282496"/>
                    </a:ext>
                  </a:extLst>
                </a:gridCol>
                <a:gridCol w="923925">
                  <a:extLst>
                    <a:ext uri="{9D8B030D-6E8A-4147-A177-3AD203B41FA5}">
                      <a16:colId xmlns:a16="http://schemas.microsoft.com/office/drawing/2014/main" val="722107059"/>
                    </a:ext>
                  </a:extLst>
                </a:gridCol>
                <a:gridCol w="1117225">
                  <a:extLst>
                    <a:ext uri="{9D8B030D-6E8A-4147-A177-3AD203B41FA5}">
                      <a16:colId xmlns:a16="http://schemas.microsoft.com/office/drawing/2014/main" val="988285634"/>
                    </a:ext>
                  </a:extLst>
                </a:gridCol>
                <a:gridCol w="790575">
                  <a:extLst>
                    <a:ext uri="{9D8B030D-6E8A-4147-A177-3AD203B41FA5}">
                      <a16:colId xmlns:a16="http://schemas.microsoft.com/office/drawing/2014/main" val="1806721265"/>
                    </a:ext>
                  </a:extLst>
                </a:gridCol>
                <a:gridCol w="1181100">
                  <a:extLst>
                    <a:ext uri="{9D8B030D-6E8A-4147-A177-3AD203B41FA5}">
                      <a16:colId xmlns:a16="http://schemas.microsoft.com/office/drawing/2014/main" val="3885661484"/>
                    </a:ext>
                  </a:extLst>
                </a:gridCol>
                <a:gridCol w="2076449">
                  <a:extLst>
                    <a:ext uri="{9D8B030D-6E8A-4147-A177-3AD203B41FA5}">
                      <a16:colId xmlns:a16="http://schemas.microsoft.com/office/drawing/2014/main" val="190413371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x</a:t>
                      </a:r>
                    </a:p>
                  </a:txBody>
                  <a:tcPr marL="39500" marR="39500" marT="79000" marB="7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 dirty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due</a:t>
                      </a:r>
                    </a:p>
                  </a:txBody>
                  <a:tcPr marL="39500" marR="39500" marT="79000" marB="7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</a:t>
                      </a:r>
                    </a:p>
                  </a:txBody>
                  <a:tcPr marL="39500" marR="39500" marT="79000" marB="7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 dirty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nce H-A</a:t>
                      </a:r>
                    </a:p>
                  </a:txBody>
                  <a:tcPr marL="39500" marR="39500" marT="79000" marB="7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 dirty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nce D-A</a:t>
                      </a:r>
                    </a:p>
                  </a:txBody>
                  <a:tcPr marL="39500" marR="39500" marT="79000" marB="7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 dirty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 Angle</a:t>
                      </a:r>
                    </a:p>
                  </a:txBody>
                  <a:tcPr marL="39500" marR="39500" marT="79000" marB="7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donor?</a:t>
                      </a:r>
                    </a:p>
                  </a:txBody>
                  <a:tcPr marL="39500" marR="39500" marT="79000" marB="7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de chain</a:t>
                      </a:r>
                    </a:p>
                  </a:txBody>
                  <a:tcPr marL="39500" marR="39500" marT="79000" marB="7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 Atom</a:t>
                      </a:r>
                    </a:p>
                  </a:txBody>
                  <a:tcPr marL="39500" marR="39500" marT="79000" marB="7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IN" sz="1200" b="0">
                          <a:solidFill>
                            <a:srgbClr val="00567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ptor Atom</a:t>
                      </a:r>
                    </a:p>
                  </a:txBody>
                  <a:tcPr marL="39500" marR="39500" marT="79000" marB="7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59776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9A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1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9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8.90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92 [O3]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00 [O2]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567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4719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5A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G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2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8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3.71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26 [Ng+]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93 [O2]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44626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5A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G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4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2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.87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27 [Ng+]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IN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93 [O2]</a:t>
                      </a:r>
                    </a:p>
                  </a:txBody>
                  <a:tcPr marL="47625" marR="47625" marT="47625" marB="4762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5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8496485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B5521A99-9312-D3D8-83E7-021E65203816}"/>
              </a:ext>
            </a:extLst>
          </p:cNvPr>
          <p:cNvSpPr txBox="1"/>
          <p:nvPr/>
        </p:nvSpPr>
        <p:spPr>
          <a:xfrm>
            <a:off x="1103500" y="1205528"/>
            <a:ext cx="24669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IN" sz="1400" b="0" i="0" dirty="0">
                <a:solidFill>
                  <a:srgbClr val="00567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ydrogen Bonds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4078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104</Words>
  <PresentationFormat>Widescreen</PresentationFormat>
  <Paragraphs>6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05T10:01:10Z</dcterms:created>
  <dcterms:modified xsi:type="dcterms:W3CDTF">2023-10-02T09:31:04Z</dcterms:modified>
</cp:coreProperties>
</file>